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47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ang Ho" userId="3459b55388f68bf5" providerId="LiveId" clId="{DB6D04B8-23A2-4824-939C-61E8FB447179}"/>
    <pc:docChg chg="undo custSel addSld delSld">
      <pc:chgData name="Kang Ho" userId="3459b55388f68bf5" providerId="LiveId" clId="{DB6D04B8-23A2-4824-939C-61E8FB447179}" dt="2021-10-09T13:09:21.651" v="1" actId="47"/>
      <pc:docMkLst>
        <pc:docMk/>
      </pc:docMkLst>
      <pc:sldChg chg="add del">
        <pc:chgData name="Kang Ho" userId="3459b55388f68bf5" providerId="LiveId" clId="{DB6D04B8-23A2-4824-939C-61E8FB447179}" dt="2021-10-09T13:09:21.651" v="1" actId="47"/>
        <pc:sldMkLst>
          <pc:docMk/>
          <pc:sldMk cId="581015048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8FA13C-6506-4815-BD51-3BEED327CA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448DDA-A305-48FA-9C49-5246BA3241F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27CA48-7FBF-40B3-A532-C61D99093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52B909-BF9E-43EE-B2F8-93ADE9DA7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B34613-BDD7-4970-B0B9-810556B98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638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48D2E3-3548-4B54-AE41-29637C465F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BBD288E-1E46-4E14-95F1-4FA729EC0F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BC4384-4680-4F34-B98A-33FE3A4BB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79A7F5-0A44-4A28-AEC6-98387F1073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7F4641-D73B-4FF6-BD8A-E15913A662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832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2E7D539-87EE-47ED-8DBE-F17C5B8BB22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311F19-0DF7-4F77-8EC4-A38C71BC80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320040-9593-4803-B856-B34CCE817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96B4B0-486A-4CBC-8896-BC258EE6E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AFB93C-468C-4E04-B11F-CC7F89FDB0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2703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0474B8-7279-48F2-A975-EDCC9BC09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C389EA-F309-4062-A865-0230E390FB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6A4275-5E11-4C67-93EA-655B9904D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E8F933-BC18-4E53-9B5F-B0FA3AF3A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1DB7BA-E3DD-43A4-BDA9-5309173D2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3599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B4D5E6-4168-440F-A821-0427CF64D5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736750-9429-4CA9-BCC1-35AF0470ED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05FA1C-1C82-4CD2-AE99-245F7102DE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86BA66-6740-4FEA-B2BF-BD527B747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435B8B-6073-4928-9AE0-FAF04F42EC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5202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6638BE-3F4C-4251-A6D6-A15B288E25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DC379B8-085F-4452-80E3-294507E870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A5BC134-EE9A-4FA4-B17C-E9829D407F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415C0C-13CC-44A9-B470-1E306113C7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400176-262E-4D17-A8AF-436EE850E1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2B30EAC-7FE0-45B3-A186-C1C369B47A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0118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1389A-62AC-475A-BB7A-C23BF0D501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2FD928-6420-4F0B-9A6A-44367FA9D2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8115F7-33C3-48AF-8372-7B404B9E2A5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BA1C39-B106-4CBE-BF35-564ADE1142B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1AFCD58-0FB2-473A-B211-46CE4A54615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0F9578-40BD-4B97-90C7-A3FC49039F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0FE8D39-B378-40B1-B96C-C0758104A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8EEF2EC-B770-4589-8D18-64ACEFF0F8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44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B00AE2-6742-415E-8858-7809889A2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00D573-2CCF-42C9-ADE5-25338FF4A0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3FB7697-BED8-481A-9470-29146A25B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52DE9B8-D62D-46F9-A65E-F3DBEE166D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219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DFC1B8-C88A-415A-A9D8-C17861BFC3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0356469-6718-4CB5-9BB5-C075B5E9B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E3B8F3D-6449-41A7-823F-FC65866051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8344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E25178-7A1F-46E3-A23A-4FCB5E9A2B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8C2381-5FC9-4152-BC81-66FB261BAC8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C6EA63-3E93-494C-A896-F59097CD38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C0226B0-9C93-4452-BAA3-A366CC839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F3D85E-F93B-4186-BA41-7F0CA45D5A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4C12E6-DA81-490E-9729-2BDBBEACF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92240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436585-AF26-4AE1-97D7-662DF13959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4C08EF-4589-4D69-88B7-7001C5C5BC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220F85-587B-4091-8B79-2E1EFAC720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09946C3-ADCB-4C48-9390-2616AF2D5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C9F1BE-9969-4872-8089-1012011BA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6C6568-0866-490B-B08D-E0020518C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461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6ACDB07-5EC5-4E98-BDB6-D69A1E77E2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80AB82-45F1-422D-B374-276576D847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4B7ADF-E236-48FE-BDB8-57A3770C82F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A7C676-BC83-4FA4-9FB8-488969137BF5}" type="datetimeFigureOut">
              <a:rPr lang="en-US" smtClean="0"/>
              <a:t>10/9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F3527F-1C74-4ECB-AC62-99B9C78D86C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51B333-6597-4142-8BC1-DAA899EC3D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9D9D69-3060-4C77-8A2D-4BA538B632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3698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16020220-1034-41D8-8383-F1623F5D24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4184" y="637226"/>
            <a:ext cx="5663675" cy="559661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1305667-C410-476E-ABB6-C913A52FCFE0}"/>
              </a:ext>
            </a:extLst>
          </p:cNvPr>
          <p:cNvSpPr txBox="1"/>
          <p:nvPr/>
        </p:nvSpPr>
        <p:spPr>
          <a:xfrm>
            <a:off x="72828" y="6405332"/>
            <a:ext cx="5661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Supplementary</a:t>
            </a:r>
            <a:r>
              <a:rPr lang="ko-KR" altLang="en-US" dirty="0"/>
              <a:t> </a:t>
            </a:r>
            <a:r>
              <a:rPr lang="en-US" altLang="ko-KR" dirty="0"/>
              <a:t>Figure 5. Raw data of western blot analysis</a:t>
            </a:r>
            <a:endParaRPr lang="ko-KR" alt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E9C0EB-2549-4879-84E3-D3F83DAA1F5E}"/>
              </a:ext>
            </a:extLst>
          </p:cNvPr>
          <p:cNvSpPr txBox="1"/>
          <p:nvPr/>
        </p:nvSpPr>
        <p:spPr>
          <a:xfrm>
            <a:off x="200216" y="34240"/>
            <a:ext cx="10001067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itl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n-depth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teomic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filing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aptures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btype-specific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Features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raniopharyngiomas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Authors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: Jung Hee Kim,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eyoon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Kisoon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an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eong-Ik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Kim,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ng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e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Park,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ohyun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an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Yong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ko-KR" alt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wy</a:t>
            </a:r>
            <a:r>
              <a: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Kim</a:t>
            </a:r>
          </a:p>
          <a:p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61523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45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Kang Ho</cp:lastModifiedBy>
  <cp:revision>6</cp:revision>
  <dcterms:created xsi:type="dcterms:W3CDTF">2021-10-09T06:02:00Z</dcterms:created>
  <dcterms:modified xsi:type="dcterms:W3CDTF">2021-10-09T13:09:22Z</dcterms:modified>
</cp:coreProperties>
</file>